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6" d="100"/>
          <a:sy n="86" d="100"/>
        </p:scale>
        <p:origin x="-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ang8:Documents:Papers,%20Review%20comments%20and%20Invention%20Disclosure:Comparison%20of%20autoclaved%20and%20non-autoclaved%20methods%20(3-2015)%20:Data:Y128%20in%202012-ACSH%20and%202010-ASGH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ang8:Documents:Papers,%20Review%20comments%20and%20Invention%20Disclosure:Comparison%20of%20autoclaved%20and%20non-autoclaved%20methods%20(3-2015)%20:Data:Y128%20in%202012-ACSH%20and%202010-ASGH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6363121603659"/>
          <c:y val="0.089462242036013"/>
          <c:w val="0.741782884246382"/>
          <c:h val="0.711555080727298"/>
        </c:manualLayout>
      </c:layout>
      <c:scatterChart>
        <c:scatterStyle val="lineMarker"/>
        <c:varyColors val="0"/>
        <c:ser>
          <c:idx val="0"/>
          <c:order val="1"/>
          <c:tx>
            <c:strRef>
              <c:f>'Y128 in NAC-2010-ASGH'!$F$1</c:f>
              <c:strCache>
                <c:ptCount val="1"/>
                <c:pt idx="0">
                  <c:v>NAC-ASGH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circ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0-ASGH'!$G$2:$G$18</c:f>
                <c:numCache>
                  <c:formatCode>General</c:formatCode>
                  <c:ptCount val="17"/>
                  <c:pt idx="0">
                    <c:v>0.0624499799839845</c:v>
                  </c:pt>
                  <c:pt idx="1">
                    <c:v>0.120554275466834</c:v>
                  </c:pt>
                  <c:pt idx="2">
                    <c:v>0.0680685928555405</c:v>
                  </c:pt>
                  <c:pt idx="3">
                    <c:v>0.07</c:v>
                  </c:pt>
                  <c:pt idx="4">
                    <c:v>0.04618802153517</c:v>
                  </c:pt>
                  <c:pt idx="5">
                    <c:v>0.0404145188432738</c:v>
                  </c:pt>
                  <c:pt idx="6">
                    <c:v>0.164620776331543</c:v>
                  </c:pt>
                  <c:pt idx="7">
                    <c:v>0.144337567297407</c:v>
                  </c:pt>
                  <c:pt idx="8">
                    <c:v>0.158771324027147</c:v>
                  </c:pt>
                  <c:pt idx="9">
                    <c:v>0.125</c:v>
                  </c:pt>
                  <c:pt idx="10">
                    <c:v>0.0901387818865997</c:v>
                  </c:pt>
                  <c:pt idx="11">
                    <c:v>0.0520416499866531</c:v>
                  </c:pt>
                  <c:pt idx="12">
                    <c:v>0.0520416499866534</c:v>
                  </c:pt>
                  <c:pt idx="13">
                    <c:v>0.250416320021945</c:v>
                  </c:pt>
                  <c:pt idx="14">
                    <c:v>0.160727512683216</c:v>
                  </c:pt>
                  <c:pt idx="15">
                    <c:v>0.0654318984390129</c:v>
                  </c:pt>
                  <c:pt idx="16">
                    <c:v>0.16393596310755</c:v>
                  </c:pt>
                </c:numCache>
              </c:numRef>
            </c:plus>
            <c:minus>
              <c:numRef>
                <c:f>'Y128 in NAC-2010-ASGH'!$G$2:$G$18</c:f>
                <c:numCache>
                  <c:formatCode>General</c:formatCode>
                  <c:ptCount val="17"/>
                  <c:pt idx="0">
                    <c:v>0.0624499799839845</c:v>
                  </c:pt>
                  <c:pt idx="1">
                    <c:v>0.120554275466834</c:v>
                  </c:pt>
                  <c:pt idx="2">
                    <c:v>0.0680685928555405</c:v>
                  </c:pt>
                  <c:pt idx="3">
                    <c:v>0.07</c:v>
                  </c:pt>
                  <c:pt idx="4">
                    <c:v>0.04618802153517</c:v>
                  </c:pt>
                  <c:pt idx="5">
                    <c:v>0.0404145188432738</c:v>
                  </c:pt>
                  <c:pt idx="6">
                    <c:v>0.164620776331543</c:v>
                  </c:pt>
                  <c:pt idx="7">
                    <c:v>0.144337567297407</c:v>
                  </c:pt>
                  <c:pt idx="8">
                    <c:v>0.158771324027147</c:v>
                  </c:pt>
                  <c:pt idx="9">
                    <c:v>0.125</c:v>
                  </c:pt>
                  <c:pt idx="10">
                    <c:v>0.0901387818865997</c:v>
                  </c:pt>
                  <c:pt idx="11">
                    <c:v>0.0520416499866531</c:v>
                  </c:pt>
                  <c:pt idx="12">
                    <c:v>0.0520416499866534</c:v>
                  </c:pt>
                  <c:pt idx="13">
                    <c:v>0.250416320021945</c:v>
                  </c:pt>
                  <c:pt idx="14">
                    <c:v>0.160727512683216</c:v>
                  </c:pt>
                  <c:pt idx="15">
                    <c:v>0.0654318984390129</c:v>
                  </c:pt>
                  <c:pt idx="16">
                    <c:v>0.1639359631075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.0"/>
          </c:errBars>
          <c:xVal>
            <c:numRef>
              <c:f>'Y128 in NAC-2010-ASGH'!$B$2:$B$18</c:f>
              <c:numCache>
                <c:formatCode>0.0</c:formatCode>
                <c:ptCount val="17"/>
                <c:pt idx="0">
                  <c:v>0.0</c:v>
                </c:pt>
                <c:pt idx="1">
                  <c:v>3.25</c:v>
                </c:pt>
                <c:pt idx="2">
                  <c:v>5.25</c:v>
                </c:pt>
                <c:pt idx="3">
                  <c:v>7.75</c:v>
                </c:pt>
                <c:pt idx="4">
                  <c:v>9.25</c:v>
                </c:pt>
                <c:pt idx="5">
                  <c:v>12.0</c:v>
                </c:pt>
                <c:pt idx="6">
                  <c:v>14.25</c:v>
                </c:pt>
                <c:pt idx="7">
                  <c:v>15.25</c:v>
                </c:pt>
                <c:pt idx="8">
                  <c:v>16.25</c:v>
                </c:pt>
                <c:pt idx="9">
                  <c:v>20.25</c:v>
                </c:pt>
                <c:pt idx="10">
                  <c:v>24.25</c:v>
                </c:pt>
                <c:pt idx="11">
                  <c:v>27.25</c:v>
                </c:pt>
                <c:pt idx="12">
                  <c:v>30.75</c:v>
                </c:pt>
                <c:pt idx="13">
                  <c:v>33.75</c:v>
                </c:pt>
                <c:pt idx="14">
                  <c:v>36.0</c:v>
                </c:pt>
                <c:pt idx="15">
                  <c:v>41.75</c:v>
                </c:pt>
                <c:pt idx="16">
                  <c:v>55.5</c:v>
                </c:pt>
              </c:numCache>
            </c:numRef>
          </c:xVal>
          <c:yVal>
            <c:numRef>
              <c:f>'Y128 in NAC-2010-ASGH'!$F$2:$F$18</c:f>
              <c:numCache>
                <c:formatCode>0.00</c:formatCode>
                <c:ptCount val="17"/>
                <c:pt idx="0">
                  <c:v>0.45</c:v>
                </c:pt>
                <c:pt idx="1">
                  <c:v>0.626666666666666</c:v>
                </c:pt>
                <c:pt idx="2">
                  <c:v>0.833333333333333</c:v>
                </c:pt>
                <c:pt idx="3">
                  <c:v>1.25</c:v>
                </c:pt>
                <c:pt idx="4">
                  <c:v>1.526666666666667</c:v>
                </c:pt>
                <c:pt idx="5">
                  <c:v>2.016666666666667</c:v>
                </c:pt>
                <c:pt idx="6">
                  <c:v>2.41</c:v>
                </c:pt>
                <c:pt idx="7">
                  <c:v>2.483333333333334</c:v>
                </c:pt>
                <c:pt idx="8">
                  <c:v>2.616666666666667</c:v>
                </c:pt>
                <c:pt idx="9">
                  <c:v>2.800000000000001</c:v>
                </c:pt>
                <c:pt idx="10">
                  <c:v>2.875</c:v>
                </c:pt>
                <c:pt idx="11">
                  <c:v>3.058333333333334</c:v>
                </c:pt>
                <c:pt idx="12">
                  <c:v>3.016666666666667</c:v>
                </c:pt>
                <c:pt idx="13">
                  <c:v>3.041666666666667</c:v>
                </c:pt>
                <c:pt idx="14">
                  <c:v>3.116666666666667</c:v>
                </c:pt>
                <c:pt idx="15">
                  <c:v>2.929333333333334</c:v>
                </c:pt>
                <c:pt idx="16">
                  <c:v>2.925000000000001</c:v>
                </c:pt>
              </c:numCache>
            </c:numRef>
          </c:yVal>
          <c:smooth val="0"/>
        </c:ser>
        <c:ser>
          <c:idx val="1"/>
          <c:order val="0"/>
          <c:tx>
            <c:strRef>
              <c:f>'Y128 in NAC-2012-ACSH'!$F$1</c:f>
              <c:strCache>
                <c:ptCount val="1"/>
                <c:pt idx="0">
                  <c:v>NAC-ACSH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1"/>
            <c:plus>
              <c:numRef>
                <c:f>'Y128 in NAC-2012-ACSH'!$G$2:$G$17</c:f>
                <c:numCache>
                  <c:formatCode>General</c:formatCode>
                  <c:ptCount val="16"/>
                  <c:pt idx="0">
                    <c:v>0.05</c:v>
                  </c:pt>
                  <c:pt idx="1">
                    <c:v>0.0461880215351702</c:v>
                  </c:pt>
                  <c:pt idx="2">
                    <c:v>0.0665832811847938</c:v>
                  </c:pt>
                  <c:pt idx="3">
                    <c:v>0.055075705472861</c:v>
                  </c:pt>
                  <c:pt idx="4">
                    <c:v>0.128290035986172</c:v>
                  </c:pt>
                  <c:pt idx="5">
                    <c:v>0.16393596310755</c:v>
                  </c:pt>
                  <c:pt idx="6">
                    <c:v>0.217944947177034</c:v>
                  </c:pt>
                  <c:pt idx="7">
                    <c:v>0.322425702035885</c:v>
                  </c:pt>
                  <c:pt idx="8">
                    <c:v>0.0866025403784441</c:v>
                  </c:pt>
                  <c:pt idx="9">
                    <c:v>0.137689263682152</c:v>
                  </c:pt>
                  <c:pt idx="10">
                    <c:v>0.180854453451755</c:v>
                  </c:pt>
                  <c:pt idx="11">
                    <c:v>0.150692844333543</c:v>
                  </c:pt>
                  <c:pt idx="12">
                    <c:v>0.188745860881769</c:v>
                  </c:pt>
                  <c:pt idx="13">
                    <c:v>0.204633819296811</c:v>
                  </c:pt>
                  <c:pt idx="14">
                    <c:v>0.0866025403784435</c:v>
                  </c:pt>
                  <c:pt idx="15">
                    <c:v>0.0381881307912987</c:v>
                  </c:pt>
                </c:numCache>
              </c:numRef>
            </c:plus>
            <c:minus>
              <c:numRef>
                <c:f>'Y128 in NAC-2012-ACSH'!$G$2:$G$17</c:f>
                <c:numCache>
                  <c:formatCode>General</c:formatCode>
                  <c:ptCount val="16"/>
                  <c:pt idx="0">
                    <c:v>0.05</c:v>
                  </c:pt>
                  <c:pt idx="1">
                    <c:v>0.0461880215351702</c:v>
                  </c:pt>
                  <c:pt idx="2">
                    <c:v>0.0665832811847938</c:v>
                  </c:pt>
                  <c:pt idx="3">
                    <c:v>0.055075705472861</c:v>
                  </c:pt>
                  <c:pt idx="4">
                    <c:v>0.128290035986172</c:v>
                  </c:pt>
                  <c:pt idx="5">
                    <c:v>0.16393596310755</c:v>
                  </c:pt>
                  <c:pt idx="6">
                    <c:v>0.217944947177034</c:v>
                  </c:pt>
                  <c:pt idx="7">
                    <c:v>0.322425702035885</c:v>
                  </c:pt>
                  <c:pt idx="8">
                    <c:v>0.0866025403784441</c:v>
                  </c:pt>
                  <c:pt idx="9">
                    <c:v>0.137689263682152</c:v>
                  </c:pt>
                  <c:pt idx="10">
                    <c:v>0.180854453451755</c:v>
                  </c:pt>
                  <c:pt idx="11">
                    <c:v>0.150692844333543</c:v>
                  </c:pt>
                  <c:pt idx="12">
                    <c:v>0.188745860881769</c:v>
                  </c:pt>
                  <c:pt idx="13">
                    <c:v>0.204633819296811</c:v>
                  </c:pt>
                  <c:pt idx="14">
                    <c:v>0.0866025403784435</c:v>
                  </c:pt>
                  <c:pt idx="15">
                    <c:v>0.0381881307912987</c:v>
                  </c:pt>
                </c:numCache>
              </c:numRef>
            </c:minus>
          </c:errBars>
          <c:xVal>
            <c:numRef>
              <c:f>'Y128 in NAC-2012-ACSH'!$B$2:$B$17</c:f>
              <c:numCache>
                <c:formatCode>0.0</c:formatCode>
                <c:ptCount val="1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5</c:v>
                </c:pt>
                <c:pt idx="4">
                  <c:v>9.0</c:v>
                </c:pt>
                <c:pt idx="5">
                  <c:v>11.5</c:v>
                </c:pt>
                <c:pt idx="6">
                  <c:v>13.0</c:v>
                </c:pt>
                <c:pt idx="7">
                  <c:v>16.0</c:v>
                </c:pt>
                <c:pt idx="8">
                  <c:v>19.5</c:v>
                </c:pt>
                <c:pt idx="9">
                  <c:v>22.0</c:v>
                </c:pt>
                <c:pt idx="10">
                  <c:v>24.5</c:v>
                </c:pt>
                <c:pt idx="11">
                  <c:v>26.5</c:v>
                </c:pt>
                <c:pt idx="12">
                  <c:v>28.5</c:v>
                </c:pt>
                <c:pt idx="13">
                  <c:v>32.5</c:v>
                </c:pt>
                <c:pt idx="14">
                  <c:v>43.0</c:v>
                </c:pt>
                <c:pt idx="15">
                  <c:v>50.8</c:v>
                </c:pt>
              </c:numCache>
            </c:numRef>
          </c:xVal>
          <c:yVal>
            <c:numRef>
              <c:f>'Y128 in NAC-2012-ACSH'!$F$2:$F$17</c:f>
              <c:numCache>
                <c:formatCode>0.00</c:formatCode>
                <c:ptCount val="16"/>
                <c:pt idx="0">
                  <c:v>0.48</c:v>
                </c:pt>
                <c:pt idx="1">
                  <c:v>0.676666666666667</c:v>
                </c:pt>
                <c:pt idx="2">
                  <c:v>0.923333333333333</c:v>
                </c:pt>
                <c:pt idx="3">
                  <c:v>1.573333333333333</c:v>
                </c:pt>
                <c:pt idx="4">
                  <c:v>2.216666666666667</c:v>
                </c:pt>
                <c:pt idx="5">
                  <c:v>3.325</c:v>
                </c:pt>
                <c:pt idx="6">
                  <c:v>3.975</c:v>
                </c:pt>
                <c:pt idx="7">
                  <c:v>4.241666666666668</c:v>
                </c:pt>
                <c:pt idx="8">
                  <c:v>4.224999999999995</c:v>
                </c:pt>
                <c:pt idx="9">
                  <c:v>4.091666666666666</c:v>
                </c:pt>
                <c:pt idx="10">
                  <c:v>4.233333333333338</c:v>
                </c:pt>
                <c:pt idx="11">
                  <c:v>4.383333333333332</c:v>
                </c:pt>
                <c:pt idx="12">
                  <c:v>4.675</c:v>
                </c:pt>
                <c:pt idx="13">
                  <c:v>4.7</c:v>
                </c:pt>
                <c:pt idx="14">
                  <c:v>4.7</c:v>
                </c:pt>
                <c:pt idx="15">
                  <c:v>4.65833333333333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34593528"/>
        <c:axId val="-2034345848"/>
      </c:scatterChart>
      <c:valAx>
        <c:axId val="-2034593528"/>
        <c:scaling>
          <c:orientation val="minMax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Time (h)</a:t>
                </a:r>
              </a:p>
            </c:rich>
          </c:tx>
          <c:layout>
            <c:manualLayout>
              <c:xMode val="edge"/>
              <c:yMode val="edge"/>
              <c:x val="0.437604357535888"/>
              <c:y val="0.88653293030077"/>
            </c:manualLayout>
          </c:layout>
          <c:overlay val="0"/>
        </c:title>
        <c:numFmt formatCode="0" sourceLinked="0"/>
        <c:majorTickMark val="out"/>
        <c:minorTickMark val="in"/>
        <c:tickLblPos val="nextTo"/>
        <c:crossAx val="-2034345848"/>
        <c:crossesAt val="0.1"/>
        <c:crossBetween val="midCat"/>
      </c:valAx>
      <c:valAx>
        <c:axId val="-2034345848"/>
        <c:scaling>
          <c:logBase val="10.0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dirty="0"/>
                  <a:t>OD</a:t>
                </a:r>
                <a:r>
                  <a:rPr lang="en-US" sz="1600" baseline="-25000" dirty="0"/>
                  <a:t>600</a:t>
                </a:r>
              </a:p>
            </c:rich>
          </c:tx>
          <c:layout>
            <c:manualLayout>
              <c:xMode val="edge"/>
              <c:yMode val="edge"/>
              <c:x val="0.00705994411988824"/>
              <c:y val="0.375785452561004"/>
            </c:manualLayout>
          </c:layout>
          <c:overlay val="0"/>
        </c:title>
        <c:numFmt formatCode="0" sourceLinked="0"/>
        <c:majorTickMark val="out"/>
        <c:minorTickMark val="in"/>
        <c:tickLblPos val="nextTo"/>
        <c:crossAx val="-2034593528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462000080966743"/>
          <c:y val="0.495485160508783"/>
          <c:w val="0.28066129587272"/>
          <c:h val="0.157040339188371"/>
        </c:manualLayout>
      </c:layout>
      <c:overlay val="0"/>
      <c:spPr>
        <a:solidFill>
          <a:srgbClr val="FFFFFF"/>
        </a:solidFill>
        <a:ln w="9525" cap="flat" cmpd="sng" algn="ctr">
          <a:solidFill>
            <a:srgbClr val="000000"/>
          </a:solidFill>
          <a:prstDash val="solid"/>
        </a:ln>
        <a:effectLst/>
      </c:spPr>
    </c:legend>
    <c:plotVisOnly val="1"/>
    <c:dispBlanksAs val="gap"/>
    <c:showDLblsOverMax val="0"/>
  </c:chart>
  <c:spPr>
    <a:solidFill>
      <a:srgbClr val="FFFFFF"/>
    </a:solidFill>
    <a:ln w="9525" cap="flat" cmpd="sng" algn="ctr">
      <a:solidFill>
        <a:srgbClr val="000000"/>
      </a:solidFill>
      <a:prstDash val="solid"/>
    </a:ln>
    <a:effectLst/>
  </c:spPr>
  <c:txPr>
    <a:bodyPr/>
    <a:lstStyle/>
    <a:p>
      <a:pPr>
        <a:defRPr sz="140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65305978095"/>
          <c:y val="0.0899568397600399"/>
          <c:w val="0.720059965228916"/>
          <c:h val="0.710202322760084"/>
        </c:manualLayout>
      </c:layout>
      <c:scatterChart>
        <c:scatterStyle val="lineMarker"/>
        <c:varyColors val="0"/>
        <c:ser>
          <c:idx val="6"/>
          <c:order val="3"/>
          <c:tx>
            <c:strRef>
              <c:f>'Y128 in NAC-2010-ASGH'!$L$25:$L$26</c:f>
              <c:strCache>
                <c:ptCount val="1"/>
                <c:pt idx="0">
                  <c:v>NAC-ASGH Glu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circ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0-ASGH'!$Q$27:$Q$42</c:f>
                <c:numCache>
                  <c:formatCode>General</c:formatCode>
                  <c:ptCount val="16"/>
                  <c:pt idx="0">
                    <c:v>1.693369422187613</c:v>
                  </c:pt>
                  <c:pt idx="1">
                    <c:v>2.021344437084717</c:v>
                  </c:pt>
                  <c:pt idx="2">
                    <c:v>2.371883920712253</c:v>
                  </c:pt>
                  <c:pt idx="3">
                    <c:v>2.951270912674738</c:v>
                  </c:pt>
                  <c:pt idx="4">
                    <c:v>3.326534733522758</c:v>
                  </c:pt>
                  <c:pt idx="5">
                    <c:v>3.32828784812854</c:v>
                  </c:pt>
                  <c:pt idx="6">
                    <c:v>1.300320473319303</c:v>
                  </c:pt>
                  <c:pt idx="7">
                    <c:v>0.708889977358971</c:v>
                  </c:pt>
                  <c:pt idx="8">
                    <c:v>0.0542225352905353</c:v>
                  </c:pt>
                  <c:pt idx="9">
                    <c:v>0.0297377425729213</c:v>
                  </c:pt>
                  <c:pt idx="10">
                    <c:v>0.0355949434611154</c:v>
                  </c:pt>
                  <c:pt idx="11">
                    <c:v>0.0868234559321385</c:v>
                  </c:pt>
                  <c:pt idx="12">
                    <c:v>0.0840023561177502</c:v>
                  </c:pt>
                  <c:pt idx="13">
                    <c:v>0.0450377156762344</c:v>
                  </c:pt>
                  <c:pt idx="14">
                    <c:v>0.0277615441453341</c:v>
                  </c:pt>
                  <c:pt idx="15">
                    <c:v>0.0141162140816863</c:v>
                  </c:pt>
                </c:numCache>
              </c:numRef>
            </c:plus>
            <c:minus>
              <c:numRef>
                <c:f>'Y128 in NAC-2010-ASGH'!$Q$27:$Q$42</c:f>
                <c:numCache>
                  <c:formatCode>General</c:formatCode>
                  <c:ptCount val="16"/>
                  <c:pt idx="0">
                    <c:v>1.693369422187613</c:v>
                  </c:pt>
                  <c:pt idx="1">
                    <c:v>2.021344437084717</c:v>
                  </c:pt>
                  <c:pt idx="2">
                    <c:v>2.371883920712253</c:v>
                  </c:pt>
                  <c:pt idx="3">
                    <c:v>2.951270912674738</c:v>
                  </c:pt>
                  <c:pt idx="4">
                    <c:v>3.326534733522758</c:v>
                  </c:pt>
                  <c:pt idx="5">
                    <c:v>3.32828784812854</c:v>
                  </c:pt>
                  <c:pt idx="6">
                    <c:v>1.300320473319303</c:v>
                  </c:pt>
                  <c:pt idx="7">
                    <c:v>0.708889977358971</c:v>
                  </c:pt>
                  <c:pt idx="8">
                    <c:v>0.0542225352905353</c:v>
                  </c:pt>
                  <c:pt idx="9">
                    <c:v>0.0297377425729213</c:v>
                  </c:pt>
                  <c:pt idx="10">
                    <c:v>0.0355949434611154</c:v>
                  </c:pt>
                  <c:pt idx="11">
                    <c:v>0.0868234559321385</c:v>
                  </c:pt>
                  <c:pt idx="12">
                    <c:v>0.0840023561177502</c:v>
                  </c:pt>
                  <c:pt idx="13">
                    <c:v>0.0450377156762344</c:v>
                  </c:pt>
                  <c:pt idx="14">
                    <c:v>0.0277615441453341</c:v>
                  </c:pt>
                  <c:pt idx="15">
                    <c:v>0.0141162140816863</c:v>
                  </c:pt>
                </c:numCache>
              </c:numRef>
            </c:minus>
          </c:errBars>
          <c:xVal>
            <c:numRef>
              <c:f>'Y128 in NAC-2010-ASGH'!$B$27:$B$42</c:f>
              <c:numCache>
                <c:formatCode>0.0</c:formatCode>
                <c:ptCount val="16"/>
                <c:pt idx="0">
                  <c:v>0.0</c:v>
                </c:pt>
                <c:pt idx="1">
                  <c:v>3.25</c:v>
                </c:pt>
                <c:pt idx="2">
                  <c:v>5.25</c:v>
                </c:pt>
                <c:pt idx="3">
                  <c:v>7.75</c:v>
                </c:pt>
                <c:pt idx="4">
                  <c:v>9.25</c:v>
                </c:pt>
                <c:pt idx="5">
                  <c:v>12.0</c:v>
                </c:pt>
                <c:pt idx="6">
                  <c:v>14.25</c:v>
                </c:pt>
                <c:pt idx="7">
                  <c:v>16.25</c:v>
                </c:pt>
                <c:pt idx="8">
                  <c:v>20.25</c:v>
                </c:pt>
                <c:pt idx="9">
                  <c:v>24.25</c:v>
                </c:pt>
                <c:pt idx="10">
                  <c:v>27.25</c:v>
                </c:pt>
                <c:pt idx="11">
                  <c:v>30.75</c:v>
                </c:pt>
                <c:pt idx="12">
                  <c:v>33.75</c:v>
                </c:pt>
                <c:pt idx="13">
                  <c:v>36.0</c:v>
                </c:pt>
                <c:pt idx="14">
                  <c:v>41.75</c:v>
                </c:pt>
                <c:pt idx="15">
                  <c:v>55.5</c:v>
                </c:pt>
              </c:numCache>
            </c:numRef>
          </c:xVal>
          <c:yVal>
            <c:numRef>
              <c:f>'Y128 in NAC-2010-ASGH'!$L$27:$L$42</c:f>
              <c:numCache>
                <c:formatCode>0.00</c:formatCode>
                <c:ptCount val="16"/>
                <c:pt idx="0">
                  <c:v>65.8</c:v>
                </c:pt>
                <c:pt idx="1">
                  <c:v>61.21666666666659</c:v>
                </c:pt>
                <c:pt idx="2">
                  <c:v>56.26666666666662</c:v>
                </c:pt>
                <c:pt idx="3">
                  <c:v>47.25</c:v>
                </c:pt>
                <c:pt idx="4">
                  <c:v>40.63333333333333</c:v>
                </c:pt>
                <c:pt idx="5">
                  <c:v>24.75</c:v>
                </c:pt>
                <c:pt idx="6">
                  <c:v>14.81666666666667</c:v>
                </c:pt>
                <c:pt idx="7">
                  <c:v>3.27</c:v>
                </c:pt>
                <c:pt idx="8">
                  <c:v>0.322166666666667</c:v>
                </c:pt>
                <c:pt idx="9">
                  <c:v>0.221666666666667</c:v>
                </c:pt>
                <c:pt idx="10">
                  <c:v>0.1895</c:v>
                </c:pt>
                <c:pt idx="11">
                  <c:v>0.09475</c:v>
                </c:pt>
                <c:pt idx="12">
                  <c:v>0.0659166666666667</c:v>
                </c:pt>
                <c:pt idx="13">
                  <c:v>0.0566666666666667</c:v>
                </c:pt>
                <c:pt idx="14">
                  <c:v>0.0210333333333333</c:v>
                </c:pt>
                <c:pt idx="15">
                  <c:v>0.00815</c:v>
                </c:pt>
              </c:numCache>
            </c:numRef>
          </c:yVal>
          <c:smooth val="0"/>
        </c:ser>
        <c:ser>
          <c:idx val="7"/>
          <c:order val="4"/>
          <c:tx>
            <c:strRef>
              <c:f>'Y128 in NAC-2010-ASGH'!$M$25:$M$26</c:f>
              <c:strCache>
                <c:ptCount val="1"/>
                <c:pt idx="0">
                  <c:v>NAC-ASGH Xyl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squar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0-ASGH'!$R$27:$R$42</c:f>
                <c:numCache>
                  <c:formatCode>General</c:formatCode>
                  <c:ptCount val="16"/>
                  <c:pt idx="0">
                    <c:v>1.660070279636783</c:v>
                  </c:pt>
                  <c:pt idx="1">
                    <c:v>1.818653347947316</c:v>
                  </c:pt>
                  <c:pt idx="2">
                    <c:v>1.833257574192268</c:v>
                  </c:pt>
                  <c:pt idx="3">
                    <c:v>1.864358692240666</c:v>
                  </c:pt>
                  <c:pt idx="4">
                    <c:v>1.887017046381228</c:v>
                  </c:pt>
                  <c:pt idx="5">
                    <c:v>1.900219285591357</c:v>
                  </c:pt>
                  <c:pt idx="6">
                    <c:v>1.87905117900853</c:v>
                  </c:pt>
                  <c:pt idx="7">
                    <c:v>2.227853974867592</c:v>
                  </c:pt>
                  <c:pt idx="8">
                    <c:v>2.689950433248414</c:v>
                  </c:pt>
                  <c:pt idx="9">
                    <c:v>2.975035013799558</c:v>
                  </c:pt>
                  <c:pt idx="10">
                    <c:v>3.50047615808667</c:v>
                  </c:pt>
                  <c:pt idx="11">
                    <c:v>3.309456148674581</c:v>
                  </c:pt>
                  <c:pt idx="12">
                    <c:v>4.357751713900186</c:v>
                  </c:pt>
                  <c:pt idx="13">
                    <c:v>4.182403615147627</c:v>
                  </c:pt>
                  <c:pt idx="14">
                    <c:v>4.266536456346465</c:v>
                  </c:pt>
                  <c:pt idx="15">
                    <c:v>4.147690120215506</c:v>
                  </c:pt>
                </c:numCache>
              </c:numRef>
            </c:plus>
            <c:minus>
              <c:numRef>
                <c:f>'Y128 in NAC-2010-ASGH'!$R$27:$R$42</c:f>
                <c:numCache>
                  <c:formatCode>General</c:formatCode>
                  <c:ptCount val="16"/>
                  <c:pt idx="0">
                    <c:v>1.660070279636783</c:v>
                  </c:pt>
                  <c:pt idx="1">
                    <c:v>1.818653347947316</c:v>
                  </c:pt>
                  <c:pt idx="2">
                    <c:v>1.833257574192268</c:v>
                  </c:pt>
                  <c:pt idx="3">
                    <c:v>1.864358692240666</c:v>
                  </c:pt>
                  <c:pt idx="4">
                    <c:v>1.887017046381228</c:v>
                  </c:pt>
                  <c:pt idx="5">
                    <c:v>1.900219285591357</c:v>
                  </c:pt>
                  <c:pt idx="6">
                    <c:v>1.87905117900853</c:v>
                  </c:pt>
                  <c:pt idx="7">
                    <c:v>2.227853974867592</c:v>
                  </c:pt>
                  <c:pt idx="8">
                    <c:v>2.689950433248414</c:v>
                  </c:pt>
                  <c:pt idx="9">
                    <c:v>2.975035013799558</c:v>
                  </c:pt>
                  <c:pt idx="10">
                    <c:v>3.50047615808667</c:v>
                  </c:pt>
                  <c:pt idx="11">
                    <c:v>3.309456148674581</c:v>
                  </c:pt>
                  <c:pt idx="12">
                    <c:v>4.357751713900186</c:v>
                  </c:pt>
                  <c:pt idx="13">
                    <c:v>4.182403615147627</c:v>
                  </c:pt>
                  <c:pt idx="14">
                    <c:v>4.266536456346465</c:v>
                  </c:pt>
                  <c:pt idx="15">
                    <c:v>4.147690120215506</c:v>
                  </c:pt>
                </c:numCache>
              </c:numRef>
            </c:minus>
          </c:errBars>
          <c:xVal>
            <c:numRef>
              <c:f>'Y128 in NAC-2010-ASGH'!$B$27:$B$42</c:f>
              <c:numCache>
                <c:formatCode>0.0</c:formatCode>
                <c:ptCount val="16"/>
                <c:pt idx="0">
                  <c:v>0.0</c:v>
                </c:pt>
                <c:pt idx="1">
                  <c:v>3.25</c:v>
                </c:pt>
                <c:pt idx="2">
                  <c:v>5.25</c:v>
                </c:pt>
                <c:pt idx="3">
                  <c:v>7.75</c:v>
                </c:pt>
                <c:pt idx="4">
                  <c:v>9.25</c:v>
                </c:pt>
                <c:pt idx="5">
                  <c:v>12.0</c:v>
                </c:pt>
                <c:pt idx="6">
                  <c:v>14.25</c:v>
                </c:pt>
                <c:pt idx="7">
                  <c:v>16.25</c:v>
                </c:pt>
                <c:pt idx="8">
                  <c:v>20.25</c:v>
                </c:pt>
                <c:pt idx="9">
                  <c:v>24.25</c:v>
                </c:pt>
                <c:pt idx="10">
                  <c:v>27.25</c:v>
                </c:pt>
                <c:pt idx="11">
                  <c:v>30.75</c:v>
                </c:pt>
                <c:pt idx="12">
                  <c:v>33.75</c:v>
                </c:pt>
                <c:pt idx="13">
                  <c:v>36.0</c:v>
                </c:pt>
                <c:pt idx="14">
                  <c:v>41.75</c:v>
                </c:pt>
                <c:pt idx="15">
                  <c:v>55.5</c:v>
                </c:pt>
              </c:numCache>
            </c:numRef>
          </c:xVal>
          <c:yVal>
            <c:numRef>
              <c:f>'Y128 in NAC-2010-ASGH'!$M$27:$M$42</c:f>
              <c:numCache>
                <c:formatCode>0.00</c:formatCode>
                <c:ptCount val="16"/>
                <c:pt idx="0">
                  <c:v>33.28333333333333</c:v>
                </c:pt>
                <c:pt idx="1">
                  <c:v>33.75</c:v>
                </c:pt>
                <c:pt idx="2">
                  <c:v>33.68333333333334</c:v>
                </c:pt>
                <c:pt idx="3">
                  <c:v>33.91666666666658</c:v>
                </c:pt>
                <c:pt idx="4">
                  <c:v>33.83333333333334</c:v>
                </c:pt>
                <c:pt idx="5">
                  <c:v>33.18333333333333</c:v>
                </c:pt>
                <c:pt idx="6">
                  <c:v>32.48333333333333</c:v>
                </c:pt>
                <c:pt idx="7">
                  <c:v>31.23333333333329</c:v>
                </c:pt>
                <c:pt idx="8">
                  <c:v>28.9333333333333</c:v>
                </c:pt>
                <c:pt idx="9">
                  <c:v>26.8833333333333</c:v>
                </c:pt>
                <c:pt idx="10">
                  <c:v>25.33333333333329</c:v>
                </c:pt>
                <c:pt idx="11">
                  <c:v>24.1</c:v>
                </c:pt>
                <c:pt idx="12">
                  <c:v>22.5</c:v>
                </c:pt>
                <c:pt idx="13">
                  <c:v>21.4</c:v>
                </c:pt>
                <c:pt idx="14">
                  <c:v>19.53333333333329</c:v>
                </c:pt>
                <c:pt idx="15">
                  <c:v>16.43333333333329</c:v>
                </c:pt>
              </c:numCache>
            </c:numRef>
          </c:yVal>
          <c:smooth val="0"/>
        </c:ser>
        <c:ser>
          <c:idx val="8"/>
          <c:order val="5"/>
          <c:tx>
            <c:strRef>
              <c:f>'Y128 in NAC-2010-ASGH'!$O$25:$O$26</c:f>
              <c:strCache>
                <c:ptCount val="1"/>
                <c:pt idx="0">
                  <c:v>NAC-ASGH EtOH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triang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0-ASGH'!$S$27:$S$42</c:f>
                <c:numCache>
                  <c:formatCode>General</c:formatCode>
                  <c:ptCount val="16"/>
                  <c:pt idx="0">
                    <c:v>0.0237789807393</c:v>
                  </c:pt>
                  <c:pt idx="1">
                    <c:v>0.153324275094759</c:v>
                  </c:pt>
                  <c:pt idx="2">
                    <c:v>0.333429152894584</c:v>
                  </c:pt>
                  <c:pt idx="3">
                    <c:v>0.697513440730715</c:v>
                  </c:pt>
                  <c:pt idx="4">
                    <c:v>0.891141589947037</c:v>
                  </c:pt>
                  <c:pt idx="5">
                    <c:v>1.155782563172388</c:v>
                  </c:pt>
                  <c:pt idx="6">
                    <c:v>0.0763762615825965</c:v>
                  </c:pt>
                  <c:pt idx="7">
                    <c:v>0.375277674973257</c:v>
                  </c:pt>
                  <c:pt idx="8">
                    <c:v>0.721110255092799</c:v>
                  </c:pt>
                  <c:pt idx="9">
                    <c:v>0.707695791518738</c:v>
                  </c:pt>
                  <c:pt idx="10">
                    <c:v>0.843109324662781</c:v>
                  </c:pt>
                  <c:pt idx="11">
                    <c:v>1.02591422643416</c:v>
                  </c:pt>
                  <c:pt idx="12">
                    <c:v>1.0610529361598</c:v>
                  </c:pt>
                  <c:pt idx="13">
                    <c:v>0.923760430703401</c:v>
                  </c:pt>
                  <c:pt idx="14">
                    <c:v>0.982768199187037</c:v>
                  </c:pt>
                  <c:pt idx="15">
                    <c:v>0.992891400573765</c:v>
                  </c:pt>
                </c:numCache>
              </c:numRef>
            </c:plus>
            <c:minus>
              <c:numRef>
                <c:f>'Y128 in NAC-2010-ASGH'!$S$27:$S$42</c:f>
                <c:numCache>
                  <c:formatCode>General</c:formatCode>
                  <c:ptCount val="16"/>
                  <c:pt idx="0">
                    <c:v>0.0237789807393</c:v>
                  </c:pt>
                  <c:pt idx="1">
                    <c:v>0.153324275094759</c:v>
                  </c:pt>
                  <c:pt idx="2">
                    <c:v>0.333429152894584</c:v>
                  </c:pt>
                  <c:pt idx="3">
                    <c:v>0.697513440730715</c:v>
                  </c:pt>
                  <c:pt idx="4">
                    <c:v>0.891141589947037</c:v>
                  </c:pt>
                  <c:pt idx="5">
                    <c:v>1.155782563172388</c:v>
                  </c:pt>
                  <c:pt idx="6">
                    <c:v>0.0763762615825965</c:v>
                  </c:pt>
                  <c:pt idx="7">
                    <c:v>0.375277674973257</c:v>
                  </c:pt>
                  <c:pt idx="8">
                    <c:v>0.721110255092799</c:v>
                  </c:pt>
                  <c:pt idx="9">
                    <c:v>0.707695791518738</c:v>
                  </c:pt>
                  <c:pt idx="10">
                    <c:v>0.843109324662781</c:v>
                  </c:pt>
                  <c:pt idx="11">
                    <c:v>1.02591422643416</c:v>
                  </c:pt>
                  <c:pt idx="12">
                    <c:v>1.0610529361598</c:v>
                  </c:pt>
                  <c:pt idx="13">
                    <c:v>0.923760430703401</c:v>
                  </c:pt>
                  <c:pt idx="14">
                    <c:v>0.982768199187037</c:v>
                  </c:pt>
                  <c:pt idx="15">
                    <c:v>0.992891400573765</c:v>
                  </c:pt>
                </c:numCache>
              </c:numRef>
            </c:minus>
          </c:errBars>
          <c:xVal>
            <c:numRef>
              <c:f>'Y128 in NAC-2010-ASGH'!$B$27:$B$42</c:f>
              <c:numCache>
                <c:formatCode>0.0</c:formatCode>
                <c:ptCount val="16"/>
                <c:pt idx="0">
                  <c:v>0.0</c:v>
                </c:pt>
                <c:pt idx="1">
                  <c:v>3.25</c:v>
                </c:pt>
                <c:pt idx="2">
                  <c:v>5.25</c:v>
                </c:pt>
                <c:pt idx="3">
                  <c:v>7.75</c:v>
                </c:pt>
                <c:pt idx="4">
                  <c:v>9.25</c:v>
                </c:pt>
                <c:pt idx="5">
                  <c:v>12.0</c:v>
                </c:pt>
                <c:pt idx="6">
                  <c:v>14.25</c:v>
                </c:pt>
                <c:pt idx="7">
                  <c:v>16.25</c:v>
                </c:pt>
                <c:pt idx="8">
                  <c:v>20.25</c:v>
                </c:pt>
                <c:pt idx="9">
                  <c:v>24.25</c:v>
                </c:pt>
                <c:pt idx="10">
                  <c:v>27.25</c:v>
                </c:pt>
                <c:pt idx="11">
                  <c:v>30.75</c:v>
                </c:pt>
                <c:pt idx="12">
                  <c:v>33.75</c:v>
                </c:pt>
                <c:pt idx="13">
                  <c:v>36.0</c:v>
                </c:pt>
                <c:pt idx="14">
                  <c:v>41.75</c:v>
                </c:pt>
                <c:pt idx="15">
                  <c:v>55.5</c:v>
                </c:pt>
              </c:numCache>
            </c:numRef>
          </c:xVal>
          <c:yVal>
            <c:numRef>
              <c:f>'Y128 in NAC-2010-ASGH'!$O$27:$O$42</c:f>
              <c:numCache>
                <c:formatCode>0.00</c:formatCode>
                <c:ptCount val="16"/>
                <c:pt idx="0">
                  <c:v>0.0336284</c:v>
                </c:pt>
                <c:pt idx="1">
                  <c:v>1.943066666666667</c:v>
                </c:pt>
                <c:pt idx="2">
                  <c:v>3.8584</c:v>
                </c:pt>
                <c:pt idx="3">
                  <c:v>7.7116</c:v>
                </c:pt>
                <c:pt idx="4">
                  <c:v>10.47626666666667</c:v>
                </c:pt>
                <c:pt idx="5">
                  <c:v>17.17733333333332</c:v>
                </c:pt>
                <c:pt idx="6">
                  <c:v>21.77066666666667</c:v>
                </c:pt>
                <c:pt idx="7">
                  <c:v>27.53</c:v>
                </c:pt>
                <c:pt idx="8">
                  <c:v>30.70666666666666</c:v>
                </c:pt>
                <c:pt idx="9">
                  <c:v>31.73333333333329</c:v>
                </c:pt>
                <c:pt idx="10">
                  <c:v>32.55333333333333</c:v>
                </c:pt>
                <c:pt idx="11">
                  <c:v>33.37666666666659</c:v>
                </c:pt>
                <c:pt idx="12">
                  <c:v>33.66333333333334</c:v>
                </c:pt>
                <c:pt idx="13">
                  <c:v>33.87833333333334</c:v>
                </c:pt>
                <c:pt idx="14">
                  <c:v>34.3</c:v>
                </c:pt>
                <c:pt idx="15">
                  <c:v>34.80833333333334</c:v>
                </c:pt>
              </c:numCache>
            </c:numRef>
          </c:yVal>
          <c:smooth val="0"/>
        </c:ser>
        <c:ser>
          <c:idx val="0"/>
          <c:order val="0"/>
          <c:tx>
            <c:strRef>
              <c:f>'Y128 in NAC-2012-ACSH'!$L$25:$L$26</c:f>
              <c:strCache>
                <c:ptCount val="1"/>
                <c:pt idx="0">
                  <c:v>NAC-ACSH Glu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2-ACSH'!$Q$27:$Q$42</c:f>
                <c:numCache>
                  <c:formatCode>General</c:formatCode>
                  <c:ptCount val="16"/>
                  <c:pt idx="0">
                    <c:v>2.430192036307695</c:v>
                  </c:pt>
                  <c:pt idx="1">
                    <c:v>2.136195996001612</c:v>
                  </c:pt>
                  <c:pt idx="2">
                    <c:v>2.038994850410371</c:v>
                  </c:pt>
                  <c:pt idx="3">
                    <c:v>2.133268228173228</c:v>
                  </c:pt>
                  <c:pt idx="4">
                    <c:v>2.414021540914665</c:v>
                  </c:pt>
                  <c:pt idx="5">
                    <c:v>2.109699820669595</c:v>
                  </c:pt>
                  <c:pt idx="6">
                    <c:v>0.998761733347851</c:v>
                  </c:pt>
                  <c:pt idx="7">
                    <c:v>0.0457775418009021</c:v>
                  </c:pt>
                  <c:pt idx="8">
                    <c:v>0.035529330606322</c:v>
                  </c:pt>
                  <c:pt idx="9">
                    <c:v>0.0465761025992228</c:v>
                  </c:pt>
                  <c:pt idx="10">
                    <c:v>0.127053466435723</c:v>
                  </c:pt>
                  <c:pt idx="11">
                    <c:v>0.0356452427868479</c:v>
                  </c:pt>
                  <c:pt idx="12">
                    <c:v>0.280781201887401</c:v>
                  </c:pt>
                  <c:pt idx="13">
                    <c:v>0.0697370597315373</c:v>
                  </c:pt>
                  <c:pt idx="14">
                    <c:v>0.0817868163785175</c:v>
                  </c:pt>
                  <c:pt idx="15">
                    <c:v>0.0772533710159844</c:v>
                  </c:pt>
                </c:numCache>
              </c:numRef>
            </c:plus>
            <c:minus>
              <c:numRef>
                <c:f>'Y128 in NAC-2012-ACSH'!$Q$27:$Q$42</c:f>
                <c:numCache>
                  <c:formatCode>General</c:formatCode>
                  <c:ptCount val="16"/>
                  <c:pt idx="0">
                    <c:v>2.430192036307695</c:v>
                  </c:pt>
                  <c:pt idx="1">
                    <c:v>2.136195996001612</c:v>
                  </c:pt>
                  <c:pt idx="2">
                    <c:v>2.038994850410371</c:v>
                  </c:pt>
                  <c:pt idx="3">
                    <c:v>2.133268228173228</c:v>
                  </c:pt>
                  <c:pt idx="4">
                    <c:v>2.414021540914665</c:v>
                  </c:pt>
                  <c:pt idx="5">
                    <c:v>2.109699820669595</c:v>
                  </c:pt>
                  <c:pt idx="6">
                    <c:v>0.998761733347851</c:v>
                  </c:pt>
                  <c:pt idx="7">
                    <c:v>0.0457775418009021</c:v>
                  </c:pt>
                  <c:pt idx="8">
                    <c:v>0.035529330606322</c:v>
                  </c:pt>
                  <c:pt idx="9">
                    <c:v>0.0465761025992228</c:v>
                  </c:pt>
                  <c:pt idx="10">
                    <c:v>0.127053466435723</c:v>
                  </c:pt>
                  <c:pt idx="11">
                    <c:v>0.0356452427868479</c:v>
                  </c:pt>
                  <c:pt idx="12">
                    <c:v>0.280781201887401</c:v>
                  </c:pt>
                  <c:pt idx="13">
                    <c:v>0.0697370597315373</c:v>
                  </c:pt>
                  <c:pt idx="14">
                    <c:v>0.0817868163785175</c:v>
                  </c:pt>
                  <c:pt idx="15">
                    <c:v>0.0772533710159844</c:v>
                  </c:pt>
                </c:numCache>
              </c:numRef>
            </c:minus>
          </c:errBars>
          <c:xVal>
            <c:numRef>
              <c:f>'Y128 in NAC-2012-ACSH'!$B$27:$B$42</c:f>
              <c:numCache>
                <c:formatCode>0.0</c:formatCode>
                <c:ptCount val="1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5</c:v>
                </c:pt>
                <c:pt idx="4">
                  <c:v>9.0</c:v>
                </c:pt>
                <c:pt idx="5">
                  <c:v>11.5</c:v>
                </c:pt>
                <c:pt idx="6">
                  <c:v>13.0</c:v>
                </c:pt>
                <c:pt idx="7" formatCode="General">
                  <c:v>16.0</c:v>
                </c:pt>
                <c:pt idx="8">
                  <c:v>19.5</c:v>
                </c:pt>
                <c:pt idx="9">
                  <c:v>22.0</c:v>
                </c:pt>
                <c:pt idx="10">
                  <c:v>24.5</c:v>
                </c:pt>
                <c:pt idx="11">
                  <c:v>26.5</c:v>
                </c:pt>
                <c:pt idx="12">
                  <c:v>28.5</c:v>
                </c:pt>
                <c:pt idx="13">
                  <c:v>32.5</c:v>
                </c:pt>
                <c:pt idx="14">
                  <c:v>43.0</c:v>
                </c:pt>
                <c:pt idx="15">
                  <c:v>50.8</c:v>
                </c:pt>
              </c:numCache>
            </c:numRef>
          </c:xVal>
          <c:yVal>
            <c:numRef>
              <c:f>'Y128 in NAC-2012-ACSH'!$L$27:$L$42</c:f>
              <c:numCache>
                <c:formatCode>0.00</c:formatCode>
                <c:ptCount val="16"/>
                <c:pt idx="0">
                  <c:v>66.71666666666666</c:v>
                </c:pt>
                <c:pt idx="1">
                  <c:v>63.16666666666659</c:v>
                </c:pt>
                <c:pt idx="2">
                  <c:v>57.3</c:v>
                </c:pt>
                <c:pt idx="3">
                  <c:v>46.83333333333334</c:v>
                </c:pt>
                <c:pt idx="4">
                  <c:v>31.6</c:v>
                </c:pt>
                <c:pt idx="5">
                  <c:v>13.06666666666667</c:v>
                </c:pt>
                <c:pt idx="6">
                  <c:v>3.685</c:v>
                </c:pt>
                <c:pt idx="7">
                  <c:v>0.623833333333333</c:v>
                </c:pt>
                <c:pt idx="8">
                  <c:v>0.525166666666667</c:v>
                </c:pt>
                <c:pt idx="9">
                  <c:v>0.529666666666667</c:v>
                </c:pt>
                <c:pt idx="10">
                  <c:v>0.424333333333333</c:v>
                </c:pt>
                <c:pt idx="11">
                  <c:v>0.533333333333333</c:v>
                </c:pt>
                <c:pt idx="12">
                  <c:v>0.217833333333333</c:v>
                </c:pt>
                <c:pt idx="13">
                  <c:v>0.07605</c:v>
                </c:pt>
                <c:pt idx="14">
                  <c:v>0.0938333333333333</c:v>
                </c:pt>
                <c:pt idx="15">
                  <c:v>0.089166666666666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Y128 in NAC-2012-ACSH'!$M$25:$M$26</c:f>
              <c:strCache>
                <c:ptCount val="1"/>
                <c:pt idx="0">
                  <c:v>NAC-ACSH Xyl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squar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2-ACSH'!$R$27:$R$42</c:f>
                <c:numCache>
                  <c:formatCode>General</c:formatCode>
                  <c:ptCount val="16"/>
                  <c:pt idx="0">
                    <c:v>0.152752523165193</c:v>
                  </c:pt>
                  <c:pt idx="1">
                    <c:v>0.125830573921177</c:v>
                  </c:pt>
                  <c:pt idx="2">
                    <c:v>0.076376261582598</c:v>
                  </c:pt>
                  <c:pt idx="3">
                    <c:v>0.30550504633039</c:v>
                  </c:pt>
                  <c:pt idx="4">
                    <c:v>0.35</c:v>
                  </c:pt>
                  <c:pt idx="5">
                    <c:v>0.0288675134594817</c:v>
                  </c:pt>
                  <c:pt idx="6">
                    <c:v>0.0763762615825969</c:v>
                  </c:pt>
                  <c:pt idx="7">
                    <c:v>0.388372673257702</c:v>
                  </c:pt>
                  <c:pt idx="8">
                    <c:v>0.825126252965772</c:v>
                  </c:pt>
                  <c:pt idx="9">
                    <c:v>1.175797601630485</c:v>
                  </c:pt>
                  <c:pt idx="10">
                    <c:v>0.901387818865997</c:v>
                  </c:pt>
                  <c:pt idx="11">
                    <c:v>1.884365498870463</c:v>
                  </c:pt>
                  <c:pt idx="12">
                    <c:v>1.703917055884273</c:v>
                  </c:pt>
                  <c:pt idx="13">
                    <c:v>2.73007936392576</c:v>
                  </c:pt>
                  <c:pt idx="14">
                    <c:v>3.394320010448828</c:v>
                  </c:pt>
                  <c:pt idx="15">
                    <c:v>3.774493343483332</c:v>
                  </c:pt>
                </c:numCache>
              </c:numRef>
            </c:plus>
            <c:minus>
              <c:numRef>
                <c:f>'Y128 in NAC-2012-ACSH'!$R$27:$R$42</c:f>
                <c:numCache>
                  <c:formatCode>General</c:formatCode>
                  <c:ptCount val="16"/>
                  <c:pt idx="0">
                    <c:v>0.152752523165193</c:v>
                  </c:pt>
                  <c:pt idx="1">
                    <c:v>0.125830573921177</c:v>
                  </c:pt>
                  <c:pt idx="2">
                    <c:v>0.076376261582598</c:v>
                  </c:pt>
                  <c:pt idx="3">
                    <c:v>0.30550504633039</c:v>
                  </c:pt>
                  <c:pt idx="4">
                    <c:v>0.35</c:v>
                  </c:pt>
                  <c:pt idx="5">
                    <c:v>0.0288675134594817</c:v>
                  </c:pt>
                  <c:pt idx="6">
                    <c:v>0.0763762615825969</c:v>
                  </c:pt>
                  <c:pt idx="7">
                    <c:v>0.388372673257702</c:v>
                  </c:pt>
                  <c:pt idx="8">
                    <c:v>0.825126252965772</c:v>
                  </c:pt>
                  <c:pt idx="9">
                    <c:v>1.175797601630485</c:v>
                  </c:pt>
                  <c:pt idx="10">
                    <c:v>0.901387818865997</c:v>
                  </c:pt>
                  <c:pt idx="11">
                    <c:v>1.884365498870463</c:v>
                  </c:pt>
                  <c:pt idx="12">
                    <c:v>1.703917055884273</c:v>
                  </c:pt>
                  <c:pt idx="13">
                    <c:v>2.73007936392576</c:v>
                  </c:pt>
                  <c:pt idx="14">
                    <c:v>3.394320010448828</c:v>
                  </c:pt>
                  <c:pt idx="15">
                    <c:v>3.774493343483332</c:v>
                  </c:pt>
                </c:numCache>
              </c:numRef>
            </c:minus>
          </c:errBars>
          <c:xVal>
            <c:numRef>
              <c:f>'Y128 in NAC-2012-ACSH'!$B$27:$B$42</c:f>
              <c:numCache>
                <c:formatCode>0.0</c:formatCode>
                <c:ptCount val="1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5</c:v>
                </c:pt>
                <c:pt idx="4">
                  <c:v>9.0</c:v>
                </c:pt>
                <c:pt idx="5">
                  <c:v>11.5</c:v>
                </c:pt>
                <c:pt idx="6">
                  <c:v>13.0</c:v>
                </c:pt>
                <c:pt idx="7" formatCode="General">
                  <c:v>16.0</c:v>
                </c:pt>
                <c:pt idx="8">
                  <c:v>19.5</c:v>
                </c:pt>
                <c:pt idx="9">
                  <c:v>22.0</c:v>
                </c:pt>
                <c:pt idx="10">
                  <c:v>24.5</c:v>
                </c:pt>
                <c:pt idx="11">
                  <c:v>26.5</c:v>
                </c:pt>
                <c:pt idx="12">
                  <c:v>28.5</c:v>
                </c:pt>
                <c:pt idx="13">
                  <c:v>32.5</c:v>
                </c:pt>
                <c:pt idx="14">
                  <c:v>43.0</c:v>
                </c:pt>
                <c:pt idx="15">
                  <c:v>50.8</c:v>
                </c:pt>
              </c:numCache>
            </c:numRef>
          </c:xVal>
          <c:yVal>
            <c:numRef>
              <c:f>'Y128 in NAC-2012-ACSH'!$M$27:$M$42</c:f>
              <c:numCache>
                <c:formatCode>0.00</c:formatCode>
                <c:ptCount val="16"/>
                <c:pt idx="0">
                  <c:v>31.73333333333329</c:v>
                </c:pt>
                <c:pt idx="1">
                  <c:v>31.91666666666667</c:v>
                </c:pt>
                <c:pt idx="2">
                  <c:v>31.86666666666666</c:v>
                </c:pt>
                <c:pt idx="3">
                  <c:v>31.66666666666667</c:v>
                </c:pt>
                <c:pt idx="4">
                  <c:v>30.95</c:v>
                </c:pt>
                <c:pt idx="5">
                  <c:v>30.08333333333329</c:v>
                </c:pt>
                <c:pt idx="6">
                  <c:v>28.76666666666667</c:v>
                </c:pt>
                <c:pt idx="7">
                  <c:v>25.36666666666666</c:v>
                </c:pt>
                <c:pt idx="8">
                  <c:v>21.51666666666667</c:v>
                </c:pt>
                <c:pt idx="9">
                  <c:v>19.35</c:v>
                </c:pt>
                <c:pt idx="10">
                  <c:v>17.3</c:v>
                </c:pt>
                <c:pt idx="11">
                  <c:v>16.16666666666667</c:v>
                </c:pt>
                <c:pt idx="12">
                  <c:v>14.01666666666667</c:v>
                </c:pt>
                <c:pt idx="13">
                  <c:v>11.06666666666667</c:v>
                </c:pt>
                <c:pt idx="14">
                  <c:v>7.823333333333333</c:v>
                </c:pt>
                <c:pt idx="15">
                  <c:v>6.58000000000000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Y128 in NAC-2012-ACSH'!$O$25:$O$26</c:f>
              <c:strCache>
                <c:ptCount val="1"/>
                <c:pt idx="0">
                  <c:v>NAC-ACSH EtOH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triang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Y128 in NAC-2012-ACSH'!$S$27:$S$42</c:f>
                <c:numCache>
                  <c:formatCode>General</c:formatCode>
                  <c:ptCount val="16"/>
                  <c:pt idx="0">
                    <c:v>0.0305825113422688</c:v>
                  </c:pt>
                  <c:pt idx="1">
                    <c:v>0.0956991814663705</c:v>
                  </c:pt>
                  <c:pt idx="2">
                    <c:v>0.268576494379782</c:v>
                  </c:pt>
                  <c:pt idx="3">
                    <c:v>0.450360966337005</c:v>
                  </c:pt>
                  <c:pt idx="4">
                    <c:v>0.757187779440036</c:v>
                  </c:pt>
                  <c:pt idx="5">
                    <c:v>0.705336798983293</c:v>
                  </c:pt>
                  <c:pt idx="6">
                    <c:v>0.568624070307731</c:v>
                  </c:pt>
                  <c:pt idx="7">
                    <c:v>0.492442890089807</c:v>
                  </c:pt>
                  <c:pt idx="8">
                    <c:v>0.173205080756888</c:v>
                  </c:pt>
                  <c:pt idx="9">
                    <c:v>0.160727512683216</c:v>
                  </c:pt>
                  <c:pt idx="10">
                    <c:v>0.225462487641146</c:v>
                  </c:pt>
                  <c:pt idx="11">
                    <c:v>0.251661147842358</c:v>
                  </c:pt>
                  <c:pt idx="12">
                    <c:v>0.404145188432738</c:v>
                  </c:pt>
                  <c:pt idx="13">
                    <c:v>0.490747728811183</c:v>
                  </c:pt>
                  <c:pt idx="14">
                    <c:v>0.923760430703402</c:v>
                  </c:pt>
                  <c:pt idx="15">
                    <c:v>1.010362971081845</c:v>
                  </c:pt>
                </c:numCache>
              </c:numRef>
            </c:plus>
            <c:minus>
              <c:numRef>
                <c:f>'Y128 in NAC-2012-ACSH'!$S$27:$S$42</c:f>
                <c:numCache>
                  <c:formatCode>General</c:formatCode>
                  <c:ptCount val="16"/>
                  <c:pt idx="0">
                    <c:v>0.0305825113422688</c:v>
                  </c:pt>
                  <c:pt idx="1">
                    <c:v>0.0956991814663705</c:v>
                  </c:pt>
                  <c:pt idx="2">
                    <c:v>0.268576494379782</c:v>
                  </c:pt>
                  <c:pt idx="3">
                    <c:v>0.450360966337005</c:v>
                  </c:pt>
                  <c:pt idx="4">
                    <c:v>0.757187779440036</c:v>
                  </c:pt>
                  <c:pt idx="5">
                    <c:v>0.705336798983293</c:v>
                  </c:pt>
                  <c:pt idx="6">
                    <c:v>0.568624070307731</c:v>
                  </c:pt>
                  <c:pt idx="7">
                    <c:v>0.492442890089807</c:v>
                  </c:pt>
                  <c:pt idx="8">
                    <c:v>0.173205080756888</c:v>
                  </c:pt>
                  <c:pt idx="9">
                    <c:v>0.160727512683216</c:v>
                  </c:pt>
                  <c:pt idx="10">
                    <c:v>0.225462487641146</c:v>
                  </c:pt>
                  <c:pt idx="11">
                    <c:v>0.251661147842358</c:v>
                  </c:pt>
                  <c:pt idx="12">
                    <c:v>0.404145188432738</c:v>
                  </c:pt>
                  <c:pt idx="13">
                    <c:v>0.490747728811183</c:v>
                  </c:pt>
                  <c:pt idx="14">
                    <c:v>0.923760430703402</c:v>
                  </c:pt>
                  <c:pt idx="15">
                    <c:v>1.010362971081845</c:v>
                  </c:pt>
                </c:numCache>
              </c:numRef>
            </c:minus>
          </c:errBars>
          <c:xVal>
            <c:numRef>
              <c:f>'Y128 in NAC-2012-ACSH'!$B$27:$B$42</c:f>
              <c:numCache>
                <c:formatCode>0.0</c:formatCode>
                <c:ptCount val="16"/>
                <c:pt idx="0">
                  <c:v>0.0</c:v>
                </c:pt>
                <c:pt idx="1">
                  <c:v>2.0</c:v>
                </c:pt>
                <c:pt idx="2">
                  <c:v>4.0</c:v>
                </c:pt>
                <c:pt idx="3">
                  <c:v>6.5</c:v>
                </c:pt>
                <c:pt idx="4">
                  <c:v>9.0</c:v>
                </c:pt>
                <c:pt idx="5">
                  <c:v>11.5</c:v>
                </c:pt>
                <c:pt idx="6">
                  <c:v>13.0</c:v>
                </c:pt>
                <c:pt idx="7" formatCode="General">
                  <c:v>16.0</c:v>
                </c:pt>
                <c:pt idx="8">
                  <c:v>19.5</c:v>
                </c:pt>
                <c:pt idx="9">
                  <c:v>22.0</c:v>
                </c:pt>
                <c:pt idx="10">
                  <c:v>24.5</c:v>
                </c:pt>
                <c:pt idx="11">
                  <c:v>26.5</c:v>
                </c:pt>
                <c:pt idx="12">
                  <c:v>28.5</c:v>
                </c:pt>
                <c:pt idx="13">
                  <c:v>32.5</c:v>
                </c:pt>
                <c:pt idx="14">
                  <c:v>43.0</c:v>
                </c:pt>
                <c:pt idx="15">
                  <c:v>50.8</c:v>
                </c:pt>
              </c:numCache>
            </c:numRef>
          </c:xVal>
          <c:yVal>
            <c:numRef>
              <c:f>'Y128 in NAC-2012-ACSH'!$O$27:$O$42</c:f>
              <c:numCache>
                <c:formatCode>0.00</c:formatCode>
                <c:ptCount val="16"/>
                <c:pt idx="0">
                  <c:v>0.0319815</c:v>
                </c:pt>
                <c:pt idx="1">
                  <c:v>1.665166666666666</c:v>
                </c:pt>
                <c:pt idx="2">
                  <c:v>4.241883333333332</c:v>
                </c:pt>
                <c:pt idx="3">
                  <c:v>8.8374</c:v>
                </c:pt>
                <c:pt idx="4">
                  <c:v>15.58733333333334</c:v>
                </c:pt>
                <c:pt idx="5">
                  <c:v>23.7415</c:v>
                </c:pt>
                <c:pt idx="6">
                  <c:v>28.30783333333332</c:v>
                </c:pt>
                <c:pt idx="7">
                  <c:v>30.1</c:v>
                </c:pt>
                <c:pt idx="8">
                  <c:v>31.84</c:v>
                </c:pt>
                <c:pt idx="9">
                  <c:v>33.07333333333334</c:v>
                </c:pt>
                <c:pt idx="10">
                  <c:v>33.82333333333334</c:v>
                </c:pt>
                <c:pt idx="11">
                  <c:v>34.33666666666658</c:v>
                </c:pt>
                <c:pt idx="12">
                  <c:v>34.51666666666657</c:v>
                </c:pt>
                <c:pt idx="13">
                  <c:v>34.97666666666657</c:v>
                </c:pt>
                <c:pt idx="14">
                  <c:v>35.49666666666658</c:v>
                </c:pt>
                <c:pt idx="15">
                  <c:v>35.5986666666666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35223832"/>
        <c:axId val="-2035218408"/>
      </c:scatterChart>
      <c:valAx>
        <c:axId val="-20352238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Time (h)</a:t>
                </a:r>
              </a:p>
            </c:rich>
          </c:tx>
          <c:layout>
            <c:manualLayout>
              <c:xMode val="edge"/>
              <c:yMode val="edge"/>
              <c:x val="0.467617799146731"/>
              <c:y val="0.894562530146394"/>
            </c:manualLayout>
          </c:layout>
          <c:overlay val="0"/>
        </c:title>
        <c:numFmt formatCode="0" sourceLinked="0"/>
        <c:majorTickMark val="out"/>
        <c:minorTickMark val="in"/>
        <c:tickLblPos val="nextTo"/>
        <c:crossAx val="-2035218408"/>
        <c:crosses val="autoZero"/>
        <c:crossBetween val="midCat"/>
      </c:valAx>
      <c:valAx>
        <c:axId val="-2035218408"/>
        <c:scaling>
          <c:orientation val="minMax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dirty="0"/>
                  <a:t>Glucose/Xylose/Ethanol (g/l)</a:t>
                </a:r>
              </a:p>
            </c:rich>
          </c:tx>
          <c:layout>
            <c:manualLayout>
              <c:xMode val="edge"/>
              <c:yMode val="edge"/>
              <c:x val="0.0206848861191152"/>
              <c:y val="0.153474639443907"/>
            </c:manualLayout>
          </c:layout>
          <c:overlay val="0"/>
        </c:title>
        <c:numFmt formatCode="0" sourceLinked="0"/>
        <c:majorTickMark val="out"/>
        <c:minorTickMark val="in"/>
        <c:tickLblPos val="nextTo"/>
        <c:crossAx val="-2035223832"/>
        <c:crosses val="autoZero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539247535497033"/>
          <c:y val="0.00121690348802545"/>
          <c:w val="0.455285977275942"/>
          <c:h val="0.405597411068733"/>
        </c:manualLayout>
      </c:layout>
      <c:overlay val="0"/>
      <c:spPr>
        <a:solidFill>
          <a:srgbClr val="FFFFFF"/>
        </a:solidFill>
        <a:ln w="9525" cap="flat" cmpd="sng" algn="ctr">
          <a:solidFill>
            <a:srgbClr val="000000"/>
          </a:solidFill>
          <a:prstDash val="solid"/>
        </a:ln>
        <a:effectLst/>
      </c:spPr>
      <c:txPr>
        <a:bodyPr/>
        <a:lstStyle/>
        <a:p>
          <a:pPr>
            <a:defRPr>
              <a:solidFill>
                <a:schemeClr val="dk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9525" cap="flat" cmpd="sng" algn="ctr">
      <a:solidFill>
        <a:srgbClr val="000000"/>
      </a:solidFill>
      <a:prstDash val="solid"/>
    </a:ln>
    <a:effectLst/>
  </c:spPr>
  <c:txPr>
    <a:bodyPr/>
    <a:lstStyle/>
    <a:p>
      <a:pPr>
        <a:defRPr sz="1400"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3E246D-0DDB-BD41-90BA-03BA39E12C2B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861616-08D1-984A-8E34-EE82F810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3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r>
              <a:rPr lang="en-US" smtClean="0"/>
              <a:t>www.glbrc.org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4A576972-59AE-4849-A42A-0C396822BBB1}" type="slidenum">
              <a:rPr lang="en-US" smtClean="0"/>
              <a:pPr>
                <a:defRPr/>
              </a:pPr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9884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17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37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75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16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108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55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7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242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654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192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45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95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>
          <a:xfrm>
            <a:off x="3025752" y="6492875"/>
            <a:ext cx="2895600" cy="365125"/>
          </a:xfrm>
        </p:spPr>
        <p:txBody>
          <a:bodyPr/>
          <a:lstStyle/>
          <a:p>
            <a:pPr>
              <a:defRPr/>
            </a:pPr>
            <a:fld id="{D0F08397-D830-4A8F-945A-D4010512A142}" type="slidenum">
              <a:rPr lang="en-US" smtClean="0"/>
              <a:pPr>
                <a:defRPr/>
              </a:pPr>
              <a:t>1</a:t>
            </a:fld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2524593" y="726827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428416" y="6308209"/>
            <a:ext cx="3107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3 </a:t>
            </a:r>
            <a:r>
              <a:rPr lang="en-US" smtClean="0"/>
              <a:t>yeast</a:t>
            </a:r>
            <a:r>
              <a:rPr lang="en-US"/>
              <a:t> </a:t>
            </a:r>
            <a:r>
              <a:rPr lang="en-US" smtClean="0"/>
              <a:t>in ACSH and ASGH</a:t>
            </a:r>
            <a:endParaRPr lang="en-US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6317915"/>
              </p:ext>
            </p:extLst>
          </p:nvPr>
        </p:nvGraphicFramePr>
        <p:xfrm>
          <a:off x="239109" y="941886"/>
          <a:ext cx="4070741" cy="3849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0270231"/>
              </p:ext>
            </p:extLst>
          </p:nvPr>
        </p:nvGraphicFramePr>
        <p:xfrm>
          <a:off x="4572000" y="960395"/>
          <a:ext cx="4297824" cy="3831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9164821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30</Words>
  <Application>Microsoft Macintosh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W Madi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owth, Sugar Utilization and Ethanol production in Autoclaved and Non-Autoclaved ACSH (Z. mobilis)</dc:title>
  <dc:creator>Yaoping Zhang</dc:creator>
  <cp:lastModifiedBy>Yaoping Zhang</cp:lastModifiedBy>
  <cp:revision>19</cp:revision>
  <cp:lastPrinted>2015-03-23T13:56:06Z</cp:lastPrinted>
  <dcterms:created xsi:type="dcterms:W3CDTF">2015-03-05T06:10:38Z</dcterms:created>
  <dcterms:modified xsi:type="dcterms:W3CDTF">2015-08-05T20:27:48Z</dcterms:modified>
</cp:coreProperties>
</file>